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8" r:id="rId2"/>
    <p:sldId id="266" r:id="rId3"/>
    <p:sldId id="267" r:id="rId4"/>
  </p:sldIdLst>
  <p:sldSz cx="7254875" cy="10383838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71" userDrawn="1">
          <p15:clr>
            <a:srgbClr val="A4A3A4"/>
          </p15:clr>
        </p15:guide>
        <p15:guide id="2" pos="22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30" autoAdjust="0"/>
  </p:normalViewPr>
  <p:slideViewPr>
    <p:cSldViewPr snapToGrid="0" showGuides="1">
      <p:cViewPr varScale="1">
        <p:scale>
          <a:sx n="78" d="100"/>
          <a:sy n="78" d="100"/>
        </p:scale>
        <p:origin x="1362" y="120"/>
      </p:cViewPr>
      <p:guideLst>
        <p:guide orient="horz" pos="3271"/>
        <p:guide pos="2285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4116" y="1699393"/>
            <a:ext cx="6166644" cy="3615114"/>
          </a:xfrm>
        </p:spPr>
        <p:txBody>
          <a:bodyPr anchor="b"/>
          <a:lstStyle>
            <a:lvl1pPr algn="ctr">
              <a:defRPr sz="47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6860" y="5453919"/>
            <a:ext cx="5441156" cy="2507023"/>
          </a:xfrm>
        </p:spPr>
        <p:txBody>
          <a:bodyPr/>
          <a:lstStyle>
            <a:lvl1pPr marL="0" indent="0" algn="ctr">
              <a:buNone/>
              <a:defRPr sz="1904"/>
            </a:lvl1pPr>
            <a:lvl2pPr marL="362742" indent="0" algn="ctr">
              <a:buNone/>
              <a:defRPr sz="1587"/>
            </a:lvl2pPr>
            <a:lvl3pPr marL="725485" indent="0" algn="ctr">
              <a:buNone/>
              <a:defRPr sz="1428"/>
            </a:lvl3pPr>
            <a:lvl4pPr marL="1088227" indent="0" algn="ctr">
              <a:buNone/>
              <a:defRPr sz="1269"/>
            </a:lvl4pPr>
            <a:lvl5pPr marL="1450970" indent="0" algn="ctr">
              <a:buNone/>
              <a:defRPr sz="1269"/>
            </a:lvl5pPr>
            <a:lvl6pPr marL="1813712" indent="0" algn="ctr">
              <a:buNone/>
              <a:defRPr sz="1269"/>
            </a:lvl6pPr>
            <a:lvl7pPr marL="2176455" indent="0" algn="ctr">
              <a:buNone/>
              <a:defRPr sz="1269"/>
            </a:lvl7pPr>
            <a:lvl8pPr marL="2539197" indent="0" algn="ctr">
              <a:buNone/>
              <a:defRPr sz="1269"/>
            </a:lvl8pPr>
            <a:lvl9pPr marL="2901940" indent="0" algn="ctr">
              <a:buNone/>
              <a:defRPr sz="1269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5368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38149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91771" y="552843"/>
            <a:ext cx="1564332" cy="879982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8773" y="552843"/>
            <a:ext cx="4602311" cy="879982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342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217067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4994" y="2588752"/>
            <a:ext cx="6257330" cy="4319387"/>
          </a:xfrm>
        </p:spPr>
        <p:txBody>
          <a:bodyPr anchor="b"/>
          <a:lstStyle>
            <a:lvl1pPr>
              <a:defRPr sz="47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4994" y="6949002"/>
            <a:ext cx="6257330" cy="2271464"/>
          </a:xfrm>
        </p:spPr>
        <p:txBody>
          <a:bodyPr/>
          <a:lstStyle>
            <a:lvl1pPr marL="0" indent="0">
              <a:buNone/>
              <a:defRPr sz="1904">
                <a:solidFill>
                  <a:schemeClr val="tx1"/>
                </a:solidFill>
              </a:defRPr>
            </a:lvl1pPr>
            <a:lvl2pPr marL="362742" indent="0">
              <a:buNone/>
              <a:defRPr sz="1587">
                <a:solidFill>
                  <a:schemeClr val="tx1">
                    <a:tint val="75000"/>
                  </a:schemeClr>
                </a:solidFill>
              </a:defRPr>
            </a:lvl2pPr>
            <a:lvl3pPr marL="725485" indent="0">
              <a:buNone/>
              <a:defRPr sz="1428">
                <a:solidFill>
                  <a:schemeClr val="tx1">
                    <a:tint val="75000"/>
                  </a:schemeClr>
                </a:solidFill>
              </a:defRPr>
            </a:lvl3pPr>
            <a:lvl4pPr marL="1088227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4pPr>
            <a:lvl5pPr marL="1450970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5pPr>
            <a:lvl6pPr marL="1813712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6pPr>
            <a:lvl7pPr marL="2176455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7pPr>
            <a:lvl8pPr marL="2539197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8pPr>
            <a:lvl9pPr marL="2901940" indent="0">
              <a:buNone/>
              <a:defRPr sz="12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55059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8773" y="2764216"/>
            <a:ext cx="3083322" cy="658845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72780" y="2764216"/>
            <a:ext cx="3083322" cy="658845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87855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717" y="552846"/>
            <a:ext cx="6257330" cy="200706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718" y="2545483"/>
            <a:ext cx="3069152" cy="1247502"/>
          </a:xfrm>
        </p:spPr>
        <p:txBody>
          <a:bodyPr anchor="b"/>
          <a:lstStyle>
            <a:lvl1pPr marL="0" indent="0">
              <a:buNone/>
              <a:defRPr sz="1904" b="1"/>
            </a:lvl1pPr>
            <a:lvl2pPr marL="362742" indent="0">
              <a:buNone/>
              <a:defRPr sz="1587" b="1"/>
            </a:lvl2pPr>
            <a:lvl3pPr marL="725485" indent="0">
              <a:buNone/>
              <a:defRPr sz="1428" b="1"/>
            </a:lvl3pPr>
            <a:lvl4pPr marL="1088227" indent="0">
              <a:buNone/>
              <a:defRPr sz="1269" b="1"/>
            </a:lvl4pPr>
            <a:lvl5pPr marL="1450970" indent="0">
              <a:buNone/>
              <a:defRPr sz="1269" b="1"/>
            </a:lvl5pPr>
            <a:lvl6pPr marL="1813712" indent="0">
              <a:buNone/>
              <a:defRPr sz="1269" b="1"/>
            </a:lvl6pPr>
            <a:lvl7pPr marL="2176455" indent="0">
              <a:buNone/>
              <a:defRPr sz="1269" b="1"/>
            </a:lvl7pPr>
            <a:lvl8pPr marL="2539197" indent="0">
              <a:buNone/>
              <a:defRPr sz="1269" b="1"/>
            </a:lvl8pPr>
            <a:lvl9pPr marL="2901940" indent="0">
              <a:buNone/>
              <a:defRPr sz="1269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9718" y="3792985"/>
            <a:ext cx="3069152" cy="557891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72781" y="2545483"/>
            <a:ext cx="3084267" cy="1247502"/>
          </a:xfrm>
        </p:spPr>
        <p:txBody>
          <a:bodyPr anchor="b"/>
          <a:lstStyle>
            <a:lvl1pPr marL="0" indent="0">
              <a:buNone/>
              <a:defRPr sz="1904" b="1"/>
            </a:lvl1pPr>
            <a:lvl2pPr marL="362742" indent="0">
              <a:buNone/>
              <a:defRPr sz="1587" b="1"/>
            </a:lvl2pPr>
            <a:lvl3pPr marL="725485" indent="0">
              <a:buNone/>
              <a:defRPr sz="1428" b="1"/>
            </a:lvl3pPr>
            <a:lvl4pPr marL="1088227" indent="0">
              <a:buNone/>
              <a:defRPr sz="1269" b="1"/>
            </a:lvl4pPr>
            <a:lvl5pPr marL="1450970" indent="0">
              <a:buNone/>
              <a:defRPr sz="1269" b="1"/>
            </a:lvl5pPr>
            <a:lvl6pPr marL="1813712" indent="0">
              <a:buNone/>
              <a:defRPr sz="1269" b="1"/>
            </a:lvl6pPr>
            <a:lvl7pPr marL="2176455" indent="0">
              <a:buNone/>
              <a:defRPr sz="1269" b="1"/>
            </a:lvl7pPr>
            <a:lvl8pPr marL="2539197" indent="0">
              <a:buNone/>
              <a:defRPr sz="1269" b="1"/>
            </a:lvl8pPr>
            <a:lvl9pPr marL="2901940" indent="0">
              <a:buNone/>
              <a:defRPr sz="1269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72781" y="3792985"/>
            <a:ext cx="3084267" cy="5578910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46918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48489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908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718" y="692256"/>
            <a:ext cx="2339886" cy="2422896"/>
          </a:xfrm>
        </p:spPr>
        <p:txBody>
          <a:bodyPr anchor="b"/>
          <a:lstStyle>
            <a:lvl1pPr>
              <a:defRPr sz="253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84267" y="1495083"/>
            <a:ext cx="3672780" cy="7379255"/>
          </a:xfrm>
        </p:spPr>
        <p:txBody>
          <a:bodyPr/>
          <a:lstStyle>
            <a:lvl1pPr>
              <a:defRPr sz="2539"/>
            </a:lvl1pPr>
            <a:lvl2pPr>
              <a:defRPr sz="2222"/>
            </a:lvl2pPr>
            <a:lvl3pPr>
              <a:defRPr sz="1904"/>
            </a:lvl3pPr>
            <a:lvl4pPr>
              <a:defRPr sz="1587"/>
            </a:lvl4pPr>
            <a:lvl5pPr>
              <a:defRPr sz="1587"/>
            </a:lvl5pPr>
            <a:lvl6pPr>
              <a:defRPr sz="1587"/>
            </a:lvl6pPr>
            <a:lvl7pPr>
              <a:defRPr sz="1587"/>
            </a:lvl7pPr>
            <a:lvl8pPr>
              <a:defRPr sz="1587"/>
            </a:lvl8pPr>
            <a:lvl9pPr>
              <a:defRPr sz="1587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9718" y="3115152"/>
            <a:ext cx="2339886" cy="5771203"/>
          </a:xfrm>
        </p:spPr>
        <p:txBody>
          <a:bodyPr/>
          <a:lstStyle>
            <a:lvl1pPr marL="0" indent="0">
              <a:buNone/>
              <a:defRPr sz="1269"/>
            </a:lvl1pPr>
            <a:lvl2pPr marL="362742" indent="0">
              <a:buNone/>
              <a:defRPr sz="1111"/>
            </a:lvl2pPr>
            <a:lvl3pPr marL="725485" indent="0">
              <a:buNone/>
              <a:defRPr sz="952"/>
            </a:lvl3pPr>
            <a:lvl4pPr marL="1088227" indent="0">
              <a:buNone/>
              <a:defRPr sz="793"/>
            </a:lvl4pPr>
            <a:lvl5pPr marL="1450970" indent="0">
              <a:buNone/>
              <a:defRPr sz="793"/>
            </a:lvl5pPr>
            <a:lvl6pPr marL="1813712" indent="0">
              <a:buNone/>
              <a:defRPr sz="793"/>
            </a:lvl6pPr>
            <a:lvl7pPr marL="2176455" indent="0">
              <a:buNone/>
              <a:defRPr sz="793"/>
            </a:lvl7pPr>
            <a:lvl8pPr marL="2539197" indent="0">
              <a:buNone/>
              <a:defRPr sz="793"/>
            </a:lvl8pPr>
            <a:lvl9pPr marL="2901940" indent="0">
              <a:buNone/>
              <a:defRPr sz="79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6667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718" y="692256"/>
            <a:ext cx="2339886" cy="2422896"/>
          </a:xfrm>
        </p:spPr>
        <p:txBody>
          <a:bodyPr anchor="b"/>
          <a:lstStyle>
            <a:lvl1pPr>
              <a:defRPr sz="2539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84267" y="1495083"/>
            <a:ext cx="3672780" cy="7379255"/>
          </a:xfrm>
        </p:spPr>
        <p:txBody>
          <a:bodyPr anchor="t"/>
          <a:lstStyle>
            <a:lvl1pPr marL="0" indent="0">
              <a:buNone/>
              <a:defRPr sz="2539"/>
            </a:lvl1pPr>
            <a:lvl2pPr marL="362742" indent="0">
              <a:buNone/>
              <a:defRPr sz="2222"/>
            </a:lvl2pPr>
            <a:lvl3pPr marL="725485" indent="0">
              <a:buNone/>
              <a:defRPr sz="1904"/>
            </a:lvl3pPr>
            <a:lvl4pPr marL="1088227" indent="0">
              <a:buNone/>
              <a:defRPr sz="1587"/>
            </a:lvl4pPr>
            <a:lvl5pPr marL="1450970" indent="0">
              <a:buNone/>
              <a:defRPr sz="1587"/>
            </a:lvl5pPr>
            <a:lvl6pPr marL="1813712" indent="0">
              <a:buNone/>
              <a:defRPr sz="1587"/>
            </a:lvl6pPr>
            <a:lvl7pPr marL="2176455" indent="0">
              <a:buNone/>
              <a:defRPr sz="1587"/>
            </a:lvl7pPr>
            <a:lvl8pPr marL="2539197" indent="0">
              <a:buNone/>
              <a:defRPr sz="1587"/>
            </a:lvl8pPr>
            <a:lvl9pPr marL="2901940" indent="0">
              <a:buNone/>
              <a:defRPr sz="1587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9718" y="3115152"/>
            <a:ext cx="2339886" cy="5771203"/>
          </a:xfrm>
        </p:spPr>
        <p:txBody>
          <a:bodyPr/>
          <a:lstStyle>
            <a:lvl1pPr marL="0" indent="0">
              <a:buNone/>
              <a:defRPr sz="1269"/>
            </a:lvl1pPr>
            <a:lvl2pPr marL="362742" indent="0">
              <a:buNone/>
              <a:defRPr sz="1111"/>
            </a:lvl2pPr>
            <a:lvl3pPr marL="725485" indent="0">
              <a:buNone/>
              <a:defRPr sz="952"/>
            </a:lvl3pPr>
            <a:lvl4pPr marL="1088227" indent="0">
              <a:buNone/>
              <a:defRPr sz="793"/>
            </a:lvl4pPr>
            <a:lvl5pPr marL="1450970" indent="0">
              <a:buNone/>
              <a:defRPr sz="793"/>
            </a:lvl5pPr>
            <a:lvl6pPr marL="1813712" indent="0">
              <a:buNone/>
              <a:defRPr sz="793"/>
            </a:lvl6pPr>
            <a:lvl7pPr marL="2176455" indent="0">
              <a:buNone/>
              <a:defRPr sz="793"/>
            </a:lvl7pPr>
            <a:lvl8pPr marL="2539197" indent="0">
              <a:buNone/>
              <a:defRPr sz="793"/>
            </a:lvl8pPr>
            <a:lvl9pPr marL="2901940" indent="0">
              <a:buNone/>
              <a:defRPr sz="793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78415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8773" y="552846"/>
            <a:ext cx="6257330" cy="20070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773" y="2764216"/>
            <a:ext cx="6257330" cy="65884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8773" y="9624282"/>
            <a:ext cx="1632347" cy="552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E024D-3B97-4701-B244-45EDCB8BC7B0}" type="datetimeFigureOut">
              <a:rPr lang="fr-FR" smtClean="0"/>
              <a:t>01/10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03178" y="9624282"/>
            <a:ext cx="2448520" cy="552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23755" y="9624282"/>
            <a:ext cx="1632347" cy="55284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C18C6A-13AD-436A-AA21-30104FA5C5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80704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25485" rtl="0" eaLnBrk="1" latinLnBrk="0" hangingPunct="1">
        <a:lnSpc>
          <a:spcPct val="90000"/>
        </a:lnSpc>
        <a:spcBef>
          <a:spcPct val="0"/>
        </a:spcBef>
        <a:buNone/>
        <a:defRPr sz="349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1371" indent="-181371" algn="l" defTabSz="725485" rtl="0" eaLnBrk="1" latinLnBrk="0" hangingPunct="1">
        <a:lnSpc>
          <a:spcPct val="90000"/>
        </a:lnSpc>
        <a:spcBef>
          <a:spcPts val="793"/>
        </a:spcBef>
        <a:buFont typeface="Arial" panose="020B0604020202020204" pitchFamily="34" charset="0"/>
        <a:buChar char="•"/>
        <a:defRPr sz="2222" kern="1200">
          <a:solidFill>
            <a:schemeClr val="tx1"/>
          </a:solidFill>
          <a:latin typeface="+mn-lt"/>
          <a:ea typeface="+mn-ea"/>
          <a:cs typeface="+mn-cs"/>
        </a:defRPr>
      </a:lvl1pPr>
      <a:lvl2pPr marL="544114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904" kern="1200">
          <a:solidFill>
            <a:schemeClr val="tx1"/>
          </a:solidFill>
          <a:latin typeface="+mn-lt"/>
          <a:ea typeface="+mn-ea"/>
          <a:cs typeface="+mn-cs"/>
        </a:defRPr>
      </a:lvl2pPr>
      <a:lvl3pPr marL="906856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587" kern="1200">
          <a:solidFill>
            <a:schemeClr val="tx1"/>
          </a:solidFill>
          <a:latin typeface="+mn-lt"/>
          <a:ea typeface="+mn-ea"/>
          <a:cs typeface="+mn-cs"/>
        </a:defRPr>
      </a:lvl3pPr>
      <a:lvl4pPr marL="1269599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4pPr>
      <a:lvl5pPr marL="1632341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5pPr>
      <a:lvl6pPr marL="1995084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6pPr>
      <a:lvl7pPr marL="2357826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7pPr>
      <a:lvl8pPr marL="2720569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8pPr>
      <a:lvl9pPr marL="3083311" indent="-181371" algn="l" defTabSz="725485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2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1pPr>
      <a:lvl2pPr marL="362742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2pPr>
      <a:lvl3pPr marL="725485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3pPr>
      <a:lvl4pPr marL="1088227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4pPr>
      <a:lvl5pPr marL="1450970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5pPr>
      <a:lvl6pPr marL="1813712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6pPr>
      <a:lvl7pPr marL="2176455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7pPr>
      <a:lvl8pPr marL="2539197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8pPr>
      <a:lvl9pPr marL="2901940" algn="l" defTabSz="725485" rtl="0" eaLnBrk="1" latinLnBrk="0" hangingPunct="1">
        <a:defRPr sz="142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6.png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>
          <a:blip r:embed="rId2" cstate="email"/>
          <a:srcRect/>
          <a:stretch>
            <a:fillRect/>
          </a:stretch>
        </p:blipFill>
        <p:spPr bwMode="auto">
          <a:xfrm>
            <a:off x="2586727" y="803109"/>
            <a:ext cx="3018145" cy="263977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4"/>
          <p:cNvPicPr>
            <a:picLocks noChangeAspect="1" noChangeArrowheads="1"/>
          </p:cNvPicPr>
          <p:nvPr/>
        </p:nvPicPr>
        <p:blipFill>
          <a:blip r:embed="rId3" cstate="email"/>
          <a:srcRect/>
          <a:stretch>
            <a:fillRect/>
          </a:stretch>
        </p:blipFill>
        <p:spPr bwMode="auto">
          <a:xfrm>
            <a:off x="2586727" y="3663116"/>
            <a:ext cx="3017559" cy="26281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5"/>
          <p:cNvPicPr>
            <a:picLocks noChangeAspect="1" noChangeArrowheads="1"/>
          </p:cNvPicPr>
          <p:nvPr/>
        </p:nvPicPr>
        <p:blipFill>
          <a:blip r:embed="rId4" cstate="email"/>
          <a:srcRect/>
          <a:stretch>
            <a:fillRect/>
          </a:stretch>
        </p:blipFill>
        <p:spPr bwMode="auto">
          <a:xfrm>
            <a:off x="2620874" y="6511539"/>
            <a:ext cx="2983413" cy="28835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 Box 8"/>
          <p:cNvSpPr txBox="1">
            <a:spLocks noChangeArrowheads="1"/>
          </p:cNvSpPr>
          <p:nvPr/>
        </p:nvSpPr>
        <p:spPr bwMode="auto">
          <a:xfrm>
            <a:off x="595303" y="803110"/>
            <a:ext cx="1599831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600" dirty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 </a:t>
            </a:r>
            <a:r>
              <a:rPr lang="fr-FR" sz="1600" dirty="0" err="1" smtClean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DendrisChip</a:t>
            </a:r>
            <a:r>
              <a:rPr lang="fr-FR" sz="1600" dirty="0" smtClean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®	</a:t>
            </a:r>
            <a:endParaRPr lang="fr-FR" sz="1600" dirty="0">
              <a:latin typeface="Times New Roman" panose="02020603050405020304" pitchFamily="18" charset="0"/>
              <a:ea typeface="Segoe UI" pitchFamily="34" charset="0"/>
              <a:cs typeface="Times New Roman" panose="02020603050405020304" pitchFamily="18" charset="0"/>
            </a:endParaRPr>
          </a:p>
        </p:txBody>
      </p:sp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595303" y="6342262"/>
            <a:ext cx="1425361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600" dirty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 Epoxy-</a:t>
            </a:r>
            <a:r>
              <a:rPr lang="fr-FR" sz="1600" dirty="0" err="1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coated</a:t>
            </a:r>
            <a:endParaRPr lang="fr-FR" sz="1600" dirty="0">
              <a:latin typeface="Times New Roman" panose="02020603050405020304" pitchFamily="18" charset="0"/>
              <a:ea typeface="Segoe UI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 Box 8"/>
          <p:cNvSpPr txBox="1">
            <a:spLocks noChangeArrowheads="1"/>
          </p:cNvSpPr>
          <p:nvPr/>
        </p:nvSpPr>
        <p:spPr bwMode="auto">
          <a:xfrm>
            <a:off x="595303" y="3572686"/>
            <a:ext cx="1952225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</a:pPr>
            <a:r>
              <a:rPr lang="fr-FR" sz="1600" dirty="0" err="1" smtClean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Aminosilane</a:t>
            </a:r>
            <a:r>
              <a:rPr lang="fr-FR" sz="1600" dirty="0">
                <a:latin typeface="Times New Roman" panose="02020603050405020304" pitchFamily="18" charset="0"/>
                <a:ea typeface="Segoe UI" pitchFamily="34" charset="0"/>
                <a:cs typeface="Times New Roman" panose="02020603050405020304" pitchFamily="18" charset="0"/>
              </a:rPr>
              <a:t>	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893568" y="89236"/>
            <a:ext cx="2180405" cy="3020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363" b="1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363" b="1" dirty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192" b="1" dirty="0" err="1">
                <a:latin typeface="Arial" panose="020B0604020202020204" pitchFamily="34" charset="0"/>
                <a:cs typeface="Arial" panose="020B0604020202020204" pitchFamily="34" charset="0"/>
              </a:rPr>
              <a:t>Senescau</a:t>
            </a:r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 et al)</a:t>
            </a:r>
          </a:p>
        </p:txBody>
      </p:sp>
    </p:spTree>
    <p:extLst>
      <p:ext uri="{BB962C8B-B14F-4D97-AF65-F5344CB8AC3E}">
        <p14:creationId xmlns:p14="http://schemas.microsoft.com/office/powerpoint/2010/main" val="35710123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067" y="740394"/>
            <a:ext cx="1889930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Hi</a:t>
            </a:r>
            <a:endParaRPr lang="fr-FR" altLang="fr-FR" sz="1050" dirty="0"/>
          </a:p>
        </p:txBody>
      </p:sp>
      <p:pic>
        <p:nvPicPr>
          <p:cNvPr id="8193" name="Image 3">
            <a:extLst>
              <a:ext uri="{FF2B5EF4-FFF2-40B4-BE49-F238E27FC236}">
                <a16:creationId xmlns="" xmlns:a16="http://schemas.microsoft.com/office/drawing/2014/main" id="{7268BAC5-7502-41D6-B2CF-9B604E6AD1D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630" y="587525"/>
            <a:ext cx="2424440" cy="236281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Image 4">
            <a:extLst>
              <a:ext uri="{FF2B5EF4-FFF2-40B4-BE49-F238E27FC236}">
                <a16:creationId xmlns="" xmlns:a16="http://schemas.microsoft.com/office/drawing/2014/main" id="{68E0CFD5-8A63-4278-8389-6B938F7EA6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47" y="553880"/>
            <a:ext cx="2411492" cy="23820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Image 5">
            <a:extLst>
              <a:ext uri="{FF2B5EF4-FFF2-40B4-BE49-F238E27FC236}">
                <a16:creationId xmlns="" xmlns:a16="http://schemas.microsoft.com/office/drawing/2014/main" id="{68E035B5-00E3-4D1E-AB0E-732093AC1EC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2021" y="2959036"/>
            <a:ext cx="2436049" cy="23260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Rectangle 8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5411" y="575535"/>
            <a:ext cx="1116909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 err="1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Lpn</a:t>
            </a:r>
            <a:endParaRPr lang="fr-FR" altLang="fr-FR" sz="1050" dirty="0"/>
          </a:p>
        </p:txBody>
      </p:sp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067" y="2965972"/>
            <a:ext cx="1889930" cy="213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100" b="1" dirty="0" err="1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Kpn</a:t>
            </a:r>
            <a:endParaRPr lang="fr-FR" altLang="fr-FR" sz="1100" dirty="0"/>
          </a:p>
        </p:txBody>
      </p:sp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5411" y="3012268"/>
            <a:ext cx="712614" cy="2135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100" b="1" dirty="0" err="1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Mca</a:t>
            </a:r>
            <a:endParaRPr lang="fr-FR" altLang="fr-FR" sz="1100" dirty="0"/>
          </a:p>
        </p:txBody>
      </p:sp>
      <p:pic>
        <p:nvPicPr>
          <p:cNvPr id="13" name="Image 6">
            <a:extLst>
              <a:ext uri="{FF2B5EF4-FFF2-40B4-BE49-F238E27FC236}">
                <a16:creationId xmlns="" xmlns:a16="http://schemas.microsoft.com/office/drawing/2014/main" id="{C8B643CC-D2DF-4B03-8A18-F562170DA5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84347" y="2978507"/>
            <a:ext cx="2399622" cy="2340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Image 9">
            <a:extLst>
              <a:ext uri="{FF2B5EF4-FFF2-40B4-BE49-F238E27FC236}">
                <a16:creationId xmlns="" xmlns:a16="http://schemas.microsoft.com/office/drawing/2014/main" id="{FB51631E-BA1D-431B-ADC2-AFF81C21770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5238" y="5373282"/>
            <a:ext cx="2412833" cy="2280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Rectangle 14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066" y="5428339"/>
            <a:ext cx="400109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Pa</a:t>
            </a:r>
            <a:endParaRPr lang="fr-FR" altLang="fr-FR" sz="1050" dirty="0"/>
          </a:p>
        </p:txBody>
      </p:sp>
      <p:pic>
        <p:nvPicPr>
          <p:cNvPr id="16" name="Image 15">
            <a:extLst>
              <a:ext uri="{FF2B5EF4-FFF2-40B4-BE49-F238E27FC236}">
                <a16:creationId xmlns="" xmlns:a16="http://schemas.microsoft.com/office/drawing/2014/main" id="{AB6ED9E4-0E59-484B-8681-1E96B2CFAD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5146" y="5373285"/>
            <a:ext cx="2334203" cy="22941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" name="Rectangle 16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45411" y="5362474"/>
            <a:ext cx="826914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>
                <a:solidFill>
                  <a:srgbClr val="000000"/>
                </a:solidFill>
                <a:latin typeface="Segoe UI" panose="020B0502040204020203" pitchFamily="34" charset="0"/>
                <a:cs typeface="Segoe UI" panose="020B0502040204020203" pitchFamily="34" charset="0"/>
              </a:rPr>
              <a:t>Nm</a:t>
            </a:r>
            <a:endParaRPr lang="fr-FR" altLang="fr-FR" sz="1050" dirty="0"/>
          </a:p>
        </p:txBody>
      </p:sp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067" y="7890671"/>
            <a:ext cx="525337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 err="1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Sau</a:t>
            </a:r>
            <a:endParaRPr lang="fr-FR" altLang="fr-FR" sz="1050" dirty="0"/>
          </a:p>
        </p:txBody>
      </p:sp>
      <p:pic>
        <p:nvPicPr>
          <p:cNvPr id="19" name="Image 10">
            <a:extLst>
              <a:ext uri="{FF2B5EF4-FFF2-40B4-BE49-F238E27FC236}">
                <a16:creationId xmlns="" xmlns:a16="http://schemas.microsoft.com/office/drawing/2014/main" id="{7C09E8AF-DE96-49E7-A1AC-45B25D3CB6C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7522" y="7737126"/>
            <a:ext cx="2370550" cy="2307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" name="Image 11">
            <a:extLst>
              <a:ext uri="{FF2B5EF4-FFF2-40B4-BE49-F238E27FC236}">
                <a16:creationId xmlns="" xmlns:a16="http://schemas.microsoft.com/office/drawing/2014/main" id="{EA1C52FA-8687-42D0-AB29-C14BB3A395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95146" y="7737126"/>
            <a:ext cx="2334203" cy="23071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1" name="Rectangle 20">
            <a:extLst>
              <a:ext uri="{FF2B5EF4-FFF2-40B4-BE49-F238E27FC236}">
                <a16:creationId xmlns="" xmlns:a16="http://schemas.microsoft.com/office/drawing/2014/main" id="{A6B49A4C-EBC9-4CAA-89AD-D01BAF9CB8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6662" y="7782688"/>
            <a:ext cx="503238" cy="2058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43807" tIns="21904" rIns="43807" bIns="21904" numCol="1" anchor="ctr" anchorCtr="0" compatLnSpc="1">
            <a:prstTxWarp prst="textNoShape">
              <a:avLst/>
            </a:prstTxWarp>
            <a:spAutoFit/>
          </a:bodyPr>
          <a:lstStyle/>
          <a:p>
            <a:pPr defTabSz="438049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fr-FR" altLang="fr-FR" sz="1050" b="1" dirty="0" err="1">
                <a:solidFill>
                  <a:srgbClr val="000000"/>
                </a:solidFill>
                <a:latin typeface="Segoe UI" panose="020B0502040204020203" pitchFamily="34" charset="0"/>
                <a:ea typeface="Calibri" panose="020F0502020204030204" pitchFamily="34" charset="0"/>
                <a:cs typeface="Segoe UI" panose="020B0502040204020203" pitchFamily="34" charset="0"/>
              </a:rPr>
              <a:t>Spn</a:t>
            </a:r>
            <a:endParaRPr lang="fr-FR" altLang="fr-FR" sz="1050" dirty="0"/>
          </a:p>
        </p:txBody>
      </p:sp>
      <p:sp>
        <p:nvSpPr>
          <p:cNvPr id="11" name="ZoneTexte 10"/>
          <p:cNvSpPr txBox="1"/>
          <p:nvPr/>
        </p:nvSpPr>
        <p:spPr>
          <a:xfrm>
            <a:off x="893568" y="89237"/>
            <a:ext cx="2082621" cy="2757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Figure S2 (</a:t>
            </a:r>
            <a:r>
              <a:rPr lang="fr-FR" sz="1192" b="1" dirty="0" err="1">
                <a:latin typeface="Arial" panose="020B0604020202020204" pitchFamily="34" charset="0"/>
                <a:cs typeface="Arial" panose="020B0604020202020204" pitchFamily="34" charset="0"/>
              </a:rPr>
              <a:t>Senescau</a:t>
            </a:r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 et al)</a:t>
            </a:r>
          </a:p>
        </p:txBody>
      </p:sp>
    </p:spTree>
    <p:extLst>
      <p:ext uri="{BB962C8B-B14F-4D97-AF65-F5344CB8AC3E}">
        <p14:creationId xmlns:p14="http://schemas.microsoft.com/office/powerpoint/2010/main" val="21753752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862199" y="370918"/>
            <a:ext cx="45514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Sau</a:t>
            </a:r>
            <a:endParaRPr lang="fr-FR" sz="1400" b="1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5742" y="578523"/>
            <a:ext cx="3134580" cy="2732027"/>
          </a:xfrm>
          <a:prstGeom prst="rect">
            <a:avLst/>
          </a:prstGeom>
        </p:spPr>
      </p:pic>
      <p:sp>
        <p:nvSpPr>
          <p:cNvPr id="8" name="ZoneTexte 7"/>
          <p:cNvSpPr txBox="1"/>
          <p:nvPr/>
        </p:nvSpPr>
        <p:spPr>
          <a:xfrm>
            <a:off x="4001830" y="323805"/>
            <a:ext cx="4745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Kpn</a:t>
            </a:r>
            <a:endParaRPr lang="fr-FR" sz="1400" b="1" dirty="0"/>
          </a:p>
        </p:txBody>
      </p:sp>
      <p:pic>
        <p:nvPicPr>
          <p:cNvPr id="9" name="Image 8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9406" y="3588288"/>
            <a:ext cx="3139875" cy="2938957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862199" y="3340979"/>
            <a:ext cx="45338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Lpn</a:t>
            </a:r>
            <a:endParaRPr lang="fr-FR" b="1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51467" y="3565268"/>
            <a:ext cx="3168457" cy="3001144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4095022" y="3331559"/>
            <a:ext cx="50273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/>
              <a:t>Mca</a:t>
            </a:r>
            <a:endParaRPr lang="fr-FR" sz="1400" b="1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9406" y="6814472"/>
            <a:ext cx="3139875" cy="2935908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939806" y="6506695"/>
            <a:ext cx="4516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Nm</a:t>
            </a:r>
          </a:p>
        </p:txBody>
      </p:sp>
      <p:pic>
        <p:nvPicPr>
          <p:cNvPr id="15" name="Image 1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851467" y="6796247"/>
            <a:ext cx="3168457" cy="2935908"/>
          </a:xfrm>
          <a:prstGeom prst="rect">
            <a:avLst/>
          </a:prstGeom>
        </p:spPr>
      </p:pic>
      <p:sp>
        <p:nvSpPr>
          <p:cNvPr id="16" name="ZoneTexte 15"/>
          <p:cNvSpPr txBox="1"/>
          <p:nvPr/>
        </p:nvSpPr>
        <p:spPr>
          <a:xfrm>
            <a:off x="4051186" y="6488470"/>
            <a:ext cx="3758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/>
              <a:t>Pa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893568" y="89237"/>
            <a:ext cx="2082621" cy="2757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Figure S3 (</a:t>
            </a:r>
            <a:r>
              <a:rPr lang="fr-FR" sz="1192" b="1" dirty="0" err="1">
                <a:latin typeface="Arial" panose="020B0604020202020204" pitchFamily="34" charset="0"/>
                <a:cs typeface="Arial" panose="020B0604020202020204" pitchFamily="34" charset="0"/>
              </a:rPr>
              <a:t>Senescau</a:t>
            </a:r>
            <a:r>
              <a:rPr lang="fr-FR" sz="1192" b="1" dirty="0">
                <a:latin typeface="Arial" panose="020B0604020202020204" pitchFamily="34" charset="0"/>
                <a:cs typeface="Arial" panose="020B0604020202020204" pitchFamily="34" charset="0"/>
              </a:rPr>
              <a:t> et al)</a:t>
            </a:r>
          </a:p>
        </p:txBody>
      </p:sp>
      <p:pic>
        <p:nvPicPr>
          <p:cNvPr id="18" name="Image 1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97868" y="584419"/>
            <a:ext cx="3111413" cy="27647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708360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93</TotalTime>
  <Words>41</Words>
  <Application>Microsoft Office PowerPoint</Application>
  <PresentationFormat>Personnalisé</PresentationFormat>
  <Paragraphs>20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egoe UI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lice</dc:creator>
  <cp:lastModifiedBy>Jean-Marie Francois</cp:lastModifiedBy>
  <cp:revision>27</cp:revision>
  <cp:lastPrinted>2017-12-21T08:44:02Z</cp:lastPrinted>
  <dcterms:created xsi:type="dcterms:W3CDTF">2017-12-13T15:41:11Z</dcterms:created>
  <dcterms:modified xsi:type="dcterms:W3CDTF">2018-10-01T14:51:05Z</dcterms:modified>
</cp:coreProperties>
</file>